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77897E6-D9FB-8B4A-B831-E3C0963A4527}" v="1" dt="2020-09-24T21:32:01.49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6327"/>
  </p:normalViewPr>
  <p:slideViewPr>
    <p:cSldViewPr snapToGrid="0" snapToObjects="1" showGuides="1">
      <p:cViewPr varScale="1">
        <p:scale>
          <a:sx n="124" d="100"/>
          <a:sy n="124" d="100"/>
        </p:scale>
        <p:origin x="544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PTIEUX Rae" userId="3a961199-96dc-4b2e-8ea9-3b6407fb953a" providerId="ADAL" clId="{577897E6-D9FB-8B4A-B831-E3C0963A4527}"/>
    <pc:docChg chg="modSld">
      <pc:chgData name="CAPTIEUX Rae" userId="3a961199-96dc-4b2e-8ea9-3b6407fb953a" providerId="ADAL" clId="{577897E6-D9FB-8B4A-B831-E3C0963A4527}" dt="2020-09-24T21:32:04.437" v="2" actId="20577"/>
      <pc:docMkLst>
        <pc:docMk/>
      </pc:docMkLst>
      <pc:sldChg chg="modSp mod">
        <pc:chgData name="CAPTIEUX Rae" userId="3a961199-96dc-4b2e-8ea9-3b6407fb953a" providerId="ADAL" clId="{577897E6-D9FB-8B4A-B831-E3C0963A4527}" dt="2020-09-24T21:32:04.437" v="2" actId="20577"/>
        <pc:sldMkLst>
          <pc:docMk/>
          <pc:sldMk cId="416151509" sldId="263"/>
        </pc:sldMkLst>
        <pc:spChg chg="mod">
          <ac:chgData name="CAPTIEUX Rae" userId="3a961199-96dc-4b2e-8ea9-3b6407fb953a" providerId="ADAL" clId="{577897E6-D9FB-8B4A-B831-E3C0963A4527}" dt="2020-09-24T21:32:04.437" v="2" actId="20577"/>
          <ac:spMkLst>
            <pc:docMk/>
            <pc:sldMk cId="416151509" sldId="263"/>
            <ac:spMk id="2" creationId="{2481BFEF-151F-9F41-99B1-748E580BF61A}"/>
          </ac:spMkLst>
        </pc:spChg>
      </pc:sldChg>
    </pc:docChg>
  </pc:docChgLst>
  <pc:docChgLst>
    <pc:chgData name="CAPTIEUX Rae" userId="3a961199-96dc-4b2e-8ea9-3b6407fb953a" providerId="ADAL" clId="{1ECC4503-7200-B644-B01D-28854C015E97}"/>
    <pc:docChg chg="custSel addSld delSld modSld">
      <pc:chgData name="CAPTIEUX Rae" userId="3a961199-96dc-4b2e-8ea9-3b6407fb953a" providerId="ADAL" clId="{1ECC4503-7200-B644-B01D-28854C015E97}" dt="2020-09-01T19:38:34.737" v="2" actId="478"/>
      <pc:docMkLst>
        <pc:docMk/>
      </pc:docMkLst>
      <pc:sldChg chg="del">
        <pc:chgData name="CAPTIEUX Rae" userId="3a961199-96dc-4b2e-8ea9-3b6407fb953a" providerId="ADAL" clId="{1ECC4503-7200-B644-B01D-28854C015E97}" dt="2020-09-01T19:38:32.343" v="1" actId="2696"/>
        <pc:sldMkLst>
          <pc:docMk/>
          <pc:sldMk cId="2243796028" sldId="261"/>
        </pc:sldMkLst>
      </pc:sldChg>
      <pc:sldChg chg="delSp add mod">
        <pc:chgData name="CAPTIEUX Rae" userId="3a961199-96dc-4b2e-8ea9-3b6407fb953a" providerId="ADAL" clId="{1ECC4503-7200-B644-B01D-28854C015E97}" dt="2020-09-01T19:38:34.737" v="2" actId="478"/>
        <pc:sldMkLst>
          <pc:docMk/>
          <pc:sldMk cId="416151509" sldId="263"/>
        </pc:sldMkLst>
        <pc:spChg chg="del">
          <ac:chgData name="CAPTIEUX Rae" userId="3a961199-96dc-4b2e-8ea9-3b6407fb953a" providerId="ADAL" clId="{1ECC4503-7200-B644-B01D-28854C015E97}" dt="2020-09-01T19:38:34.737" v="2" actId="478"/>
          <ac:spMkLst>
            <pc:docMk/>
            <pc:sldMk cId="416151509" sldId="263"/>
            <ac:spMk id="43" creationId="{30169923-FEDA-A445-877F-618D631FD694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F1FCC1-6EE6-684D-9952-4592ABBC2FE9}" type="datetimeFigureOut">
              <a:rPr lang="en-US" smtClean="0"/>
              <a:t>9/2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4F5421-11C0-BE45-B08D-FC3C1ED8B1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487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/>
              <a:t>P [2] Drug element missing</a:t>
            </a:r>
          </a:p>
          <a:p>
            <a:r>
              <a:rPr lang="en-GB"/>
              <a:t>Drug element missing [2] time element Missing</a:t>
            </a:r>
          </a:p>
          <a:p>
            <a:r>
              <a:rPr lang="en-GB"/>
              <a:t>time element Missing [1] "2009 consensus criteria"</a:t>
            </a:r>
          </a:p>
          <a:p>
            <a:r>
              <a:rPr lang="en-GB"/>
              <a:t>time element Missing [1]&lt;42</a:t>
            </a:r>
          </a:p>
          <a:p>
            <a:endParaRPr lang="en-GB"/>
          </a:p>
          <a:p>
            <a:r>
              <a:rPr lang="en-GB"/>
              <a:t>:Drug element missing #C70039</a:t>
            </a:r>
          </a:p>
          <a:p>
            <a:r>
              <a:rPr lang="en-GB"/>
              <a:t>:Time element Missing #C70039</a:t>
            </a:r>
          </a:p>
          <a:p>
            <a:r>
              <a:rPr lang="en-GB"/>
              <a:t>:"2009 consensus criteria" #C70039</a:t>
            </a:r>
          </a:p>
          <a:p>
            <a:r>
              <a:rPr lang="en-GB"/>
              <a:t>:42  #C70039</a:t>
            </a:r>
          </a:p>
          <a:p>
            <a:endParaRPr lang="en-GB"/>
          </a:p>
          <a:p>
            <a:r>
              <a:rPr lang="en-GB"/>
              <a:t>P [1] some GLT </a:t>
            </a:r>
          </a:p>
          <a:p>
            <a:r>
              <a:rPr lang="en-GB"/>
              <a:t>some GLT [1] time element Missing  </a:t>
            </a:r>
          </a:p>
          <a:p>
            <a:r>
              <a:rPr lang="en-GB"/>
              <a:t>time element Missing  [1] &lt;39ORFPG&lt;5.6 </a:t>
            </a:r>
          </a:p>
          <a:p>
            <a:endParaRPr lang="en-GB"/>
          </a:p>
          <a:p>
            <a:r>
              <a:rPr lang="en-GB"/>
              <a:t>: some GLT #5D6D7E</a:t>
            </a:r>
          </a:p>
          <a:p>
            <a:r>
              <a:rPr lang="en-GB"/>
              <a:t>: time element Missing  #C70039</a:t>
            </a:r>
          </a:p>
          <a:p>
            <a:r>
              <a:rPr lang="en-GB"/>
              <a:t>: &lt;39ORFPG&lt;5.6 #5D6D7E</a:t>
            </a:r>
          </a:p>
          <a:p>
            <a:endParaRPr lang="en-GB"/>
          </a:p>
          <a:p>
            <a:r>
              <a:rPr lang="en-GB"/>
              <a:t>P [61] Drug element present</a:t>
            </a:r>
          </a:p>
          <a:p>
            <a:r>
              <a:rPr lang="en-GB"/>
              <a:t>Drug element present [22] time element Missing</a:t>
            </a:r>
          </a:p>
          <a:p>
            <a:r>
              <a:rPr lang="en-GB"/>
              <a:t>time element Missing [1]&lt;48,FPG&lt;5.6</a:t>
            </a:r>
          </a:p>
          <a:p>
            <a:r>
              <a:rPr lang="en-GB"/>
              <a:t>time element Missing [8]&lt;42</a:t>
            </a:r>
          </a:p>
          <a:p>
            <a:r>
              <a:rPr lang="en-GB"/>
              <a:t>time element Missing [2]&lt;42&amp;FPG&lt;6.1</a:t>
            </a:r>
          </a:p>
          <a:p>
            <a:r>
              <a:rPr lang="en-GB"/>
              <a:t>time element Missing [2]&lt;42,FPG&lt;5.6</a:t>
            </a:r>
          </a:p>
          <a:p>
            <a:r>
              <a:rPr lang="en-GB"/>
              <a:t>time element Missing [1]&lt;42ORFPG&lt;5.6</a:t>
            </a:r>
          </a:p>
          <a:p>
            <a:r>
              <a:rPr lang="en-GB"/>
              <a:t>time element Missing [5]&lt;42&amp;FPG&lt;5.6</a:t>
            </a:r>
          </a:p>
          <a:p>
            <a:r>
              <a:rPr lang="en-GB"/>
              <a:t>time element Missing [1]&lt;39</a:t>
            </a:r>
          </a:p>
          <a:p>
            <a:r>
              <a:rPr lang="en-GB"/>
              <a:t>time element Missing [2]&lt;39&amp;FPG&lt;5.6</a:t>
            </a:r>
          </a:p>
          <a:p>
            <a:endParaRPr lang="en-GB"/>
          </a:p>
          <a:p>
            <a:r>
              <a:rPr lang="en-GB"/>
              <a:t>:Drug element present #5D6D7E</a:t>
            </a:r>
          </a:p>
          <a:p>
            <a:r>
              <a:rPr lang="en-GB"/>
              <a:t>:time element Missing #C70039</a:t>
            </a:r>
          </a:p>
          <a:p>
            <a:r>
              <a:rPr lang="en-GB"/>
              <a:t>:&lt;48,FPG&lt;5.6 #5D6D7E</a:t>
            </a:r>
          </a:p>
          <a:p>
            <a:r>
              <a:rPr lang="en-GB"/>
              <a:t>:&lt;48&amp;FPG&lt;5.6 #C70039 </a:t>
            </a:r>
          </a:p>
          <a:p>
            <a:r>
              <a:rPr lang="en-GB"/>
              <a:t>:&lt;42 #C70039</a:t>
            </a:r>
          </a:p>
          <a:p>
            <a:r>
              <a:rPr lang="en-GB"/>
              <a:t>:&lt;42&amp;FPG&lt;6.1 #C70039</a:t>
            </a:r>
          </a:p>
          <a:p>
            <a:r>
              <a:rPr lang="en-GB"/>
              <a:t>:&lt;42,FPG&lt;5.6 #C70039</a:t>
            </a:r>
          </a:p>
          <a:p>
            <a:r>
              <a:rPr lang="en-GB"/>
              <a:t>:&lt;42ORFPG&lt;5.6 #C70039</a:t>
            </a:r>
          </a:p>
          <a:p>
            <a:r>
              <a:rPr lang="en-GB"/>
              <a:t>:&lt;42&amp;FPG&lt;5.6 #5D6D7E</a:t>
            </a:r>
          </a:p>
          <a:p>
            <a:r>
              <a:rPr lang="en-GB"/>
              <a:t>:&lt;39&amp;FPG&lt;5.6 #5D6D7E</a:t>
            </a:r>
          </a:p>
          <a:p>
            <a:r>
              <a:rPr lang="en-GB"/>
              <a:t>:&lt;39 #5D6D7E</a:t>
            </a:r>
          </a:p>
          <a:p>
            <a:endParaRPr lang="en-GB"/>
          </a:p>
          <a:p>
            <a:r>
              <a:rPr lang="en-GB"/>
              <a:t>Drug element present [11] "AT1 year"</a:t>
            </a:r>
          </a:p>
          <a:p>
            <a:r>
              <a:rPr lang="en-GB"/>
              <a:t> "AT1 year" [7] &lt;42</a:t>
            </a:r>
          </a:p>
          <a:p>
            <a:r>
              <a:rPr lang="en-GB"/>
              <a:t> "AT1 year" [1] &lt;42&amp;FPG&lt;6.1</a:t>
            </a:r>
          </a:p>
          <a:p>
            <a:r>
              <a:rPr lang="en-GB"/>
              <a:t> "AT1 year" [1] &lt;42,FPG&lt;5.6</a:t>
            </a:r>
          </a:p>
          <a:p>
            <a:r>
              <a:rPr lang="en-GB"/>
              <a:t> "AT1 year" [2] &lt;42&amp;FPG&lt;5.6</a:t>
            </a:r>
          </a:p>
          <a:p>
            <a:endParaRPr lang="en-GB"/>
          </a:p>
          <a:p>
            <a:r>
              <a:rPr lang="en-GB"/>
              <a:t>:"AT1 year" #5D6D7E</a:t>
            </a:r>
          </a:p>
          <a:p>
            <a:r>
              <a:rPr lang="en-GB"/>
              <a:t>:&lt;42 #5D6D7E</a:t>
            </a:r>
          </a:p>
          <a:p>
            <a:r>
              <a:rPr lang="en-GB"/>
              <a:t>:&lt;42&amp;FPG&lt;6.1 #5D6D7E</a:t>
            </a:r>
          </a:p>
          <a:p>
            <a:r>
              <a:rPr lang="en-GB"/>
              <a:t>:&lt;42,FPG&lt;5.6 #5D6D7E</a:t>
            </a:r>
          </a:p>
          <a:p>
            <a:r>
              <a:rPr lang="en-GB"/>
              <a:t>:&lt;42&amp;FPG&lt;5.6 #5D6D7E</a:t>
            </a:r>
          </a:p>
          <a:p>
            <a:endParaRPr lang="en-GB"/>
          </a:p>
          <a:p>
            <a:r>
              <a:rPr lang="en-GB"/>
              <a:t>Drug element present [1] at18m</a:t>
            </a:r>
          </a:p>
          <a:p>
            <a:r>
              <a:rPr lang="en-GB"/>
              <a:t>at18m [1]&lt;42</a:t>
            </a:r>
          </a:p>
          <a:p>
            <a:endParaRPr lang="en-GB"/>
          </a:p>
          <a:p>
            <a:r>
              <a:rPr lang="en-GB"/>
              <a:t>:at18m #5D6D7E</a:t>
            </a:r>
          </a:p>
          <a:p>
            <a:r>
              <a:rPr lang="en-GB"/>
              <a:t>:&lt;42 #5D6D7E</a:t>
            </a:r>
          </a:p>
          <a:p>
            <a:endParaRPr lang="en-GB"/>
          </a:p>
          <a:p>
            <a:endParaRPr lang="en-GB"/>
          </a:p>
          <a:p>
            <a:r>
              <a:rPr lang="en-GB"/>
              <a:t>Drug element present [1] "For 90 days"</a:t>
            </a:r>
          </a:p>
          <a:p>
            <a:r>
              <a:rPr lang="en-GB"/>
              <a:t> "For 90 days" [1]&lt;42ORFPG&lt;5.6</a:t>
            </a:r>
          </a:p>
          <a:p>
            <a:endParaRPr lang="en-GB"/>
          </a:p>
          <a:p>
            <a:r>
              <a:rPr lang="en-GB"/>
              <a:t>:"For 90 days" #5D6D7E</a:t>
            </a:r>
          </a:p>
          <a:p>
            <a:r>
              <a:rPr lang="en-GB"/>
              <a:t>:&lt;42ORFPG&lt;5.6 #5D6D7E </a:t>
            </a:r>
          </a:p>
          <a:p>
            <a:endParaRPr lang="en-GB"/>
          </a:p>
          <a:p>
            <a:r>
              <a:rPr lang="en-GB"/>
              <a:t>Drug element present [1] "For6 m"</a:t>
            </a:r>
          </a:p>
          <a:p>
            <a:r>
              <a:rPr lang="en-GB"/>
              <a:t> "For6 m" [1]ADA criteria</a:t>
            </a:r>
          </a:p>
          <a:p>
            <a:endParaRPr lang="en-GB"/>
          </a:p>
          <a:p>
            <a:r>
              <a:rPr lang="en-GB"/>
              <a:t>:"For6 m" #5D6D7E</a:t>
            </a:r>
          </a:p>
          <a:p>
            <a:r>
              <a:rPr lang="en-GB"/>
              <a:t>:ADA criteria #C70039</a:t>
            </a:r>
          </a:p>
          <a:p>
            <a:endParaRPr lang="en-GB"/>
          </a:p>
          <a:p>
            <a:r>
              <a:rPr lang="en-GB"/>
              <a:t>Drug element present [25] "For 1 year"</a:t>
            </a:r>
          </a:p>
          <a:p>
            <a:r>
              <a:rPr lang="en-GB"/>
              <a:t> "For 1 year" [1]FPG&lt;5.6</a:t>
            </a:r>
          </a:p>
          <a:p>
            <a:r>
              <a:rPr lang="en-GB"/>
              <a:t>"For 1 year" [2]&lt;48&amp;FPG&lt;5.6</a:t>
            </a:r>
          </a:p>
          <a:p>
            <a:r>
              <a:rPr lang="en-GB"/>
              <a:t> "For 1 year" [8]&lt;42</a:t>
            </a:r>
          </a:p>
          <a:p>
            <a:r>
              <a:rPr lang="en-GB"/>
              <a:t> "For 1 year" [2]&lt;42,FPG&lt;5.6</a:t>
            </a:r>
          </a:p>
          <a:p>
            <a:r>
              <a:rPr lang="en-GB"/>
              <a:t> "For 1 year" [7]&lt;42&amp;FPG&lt;5.6</a:t>
            </a:r>
          </a:p>
          <a:p>
            <a:r>
              <a:rPr lang="en-GB"/>
              <a:t>"For 1 year" [2]&lt;39</a:t>
            </a:r>
          </a:p>
          <a:p>
            <a:r>
              <a:rPr lang="en-GB"/>
              <a:t>  "For 1 year" [3]&lt;39&amp;FPG&lt;5.6</a:t>
            </a:r>
          </a:p>
          <a:p>
            <a:endParaRPr lang="en-GB"/>
          </a:p>
          <a:p>
            <a:r>
              <a:rPr lang="en-GB"/>
              <a:t> :"For 1 year"  #5D6D7E </a:t>
            </a:r>
          </a:p>
          <a:p>
            <a:r>
              <a:rPr lang="en-GB"/>
              <a:t>:FPG&lt;5.6  #5D6D7E</a:t>
            </a:r>
          </a:p>
          <a:p>
            <a:r>
              <a:rPr lang="en-GB"/>
              <a:t>:&lt;48&amp;FPG&lt;5.6 #5D6D7E</a:t>
            </a:r>
          </a:p>
          <a:p>
            <a:r>
              <a:rPr lang="en-GB"/>
              <a:t>:&lt;42  #5D6D7E</a:t>
            </a:r>
          </a:p>
          <a:p>
            <a:r>
              <a:rPr lang="en-GB"/>
              <a:t>:&lt;42,FPG&lt;5.6 #5D6D7E</a:t>
            </a:r>
          </a:p>
          <a:p>
            <a:r>
              <a:rPr lang="en-GB"/>
              <a:t>:&lt;42&amp;FPG&lt;5.6  #5D6D7E </a:t>
            </a:r>
          </a:p>
          <a:p>
            <a:r>
              <a:rPr lang="en-GB"/>
              <a:t>:&lt;39 #5D6D7E</a:t>
            </a:r>
          </a:p>
          <a:p>
            <a:r>
              <a:rPr lang="en-GB"/>
              <a:t>:&lt;42&amp;FPG&lt;5.6  #5D6D7E </a:t>
            </a:r>
          </a:p>
          <a:p>
            <a:r>
              <a:rPr lang="en-GB"/>
              <a:t>:&lt;39&amp;FPG&lt;5.6 #5D6D7E</a:t>
            </a:r>
          </a:p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7F2FC4-DA11-A149-8DA6-A9037C1576B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12739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B71EB0-A153-7845-918D-63EE233F41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AA1199-ECCF-794F-B788-7B118390CE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84017F-2D67-7940-87BB-F3E67B84E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7AB245-E958-AF4A-8771-36DE47250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1F8159-0DB0-6F46-A540-364E0ED0D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541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8F296C-0359-F940-8858-359C4F93CF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CA3596-925B-3E41-9006-4F113CCC1D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B8D450-72C4-6049-AE21-A5ADE356C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15A521-501C-E446-BC62-6AC0E2CDF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8C7F82-B7A0-F34F-9FE3-A1E633209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308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172C73-F359-0840-9EC0-404F3B2D2F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26BBBC-5D13-B04F-8B0C-82AAF32181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02147A-3DE4-6A47-91CA-1E41350F4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F8119-AE33-A241-9D92-2B3027A28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DF7C97-4D99-FB4C-92C6-C0D3C6089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62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55A5AC-672F-4642-8662-7285C99D2A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5D8094-4684-2842-A93D-0B212E6D80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7C8053-5441-754A-9C65-CD2AB775D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2387DD-F2B3-0440-8788-FD56321F9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921E4-3639-4947-96B6-0712984A4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25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28924-E957-994B-8C78-3B0E7048E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D109CB-3594-A54E-A34A-76018C888C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D7F986-5A61-8B4D-8D4F-069C81260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87894D-9405-E545-B2BF-5ABD179AE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4871DA-9CE5-BB4F-8325-1678BA1F3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7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45D345-0204-2F4C-9D88-1C8495142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9492AF-542A-6A46-9ABC-DB5D53C873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E1AC9E-4545-6546-9A8C-7F4CA4EE9F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401E09-7817-8741-9E8F-C617AA36C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3BF4BC-5CEF-D64E-9D57-787461016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E667AA-8379-4540-91AA-43F6653A4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392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B8941-1A83-3A4D-B4A7-9EB1F59B1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AF4C62-9D87-5F43-B3C4-0A63819A73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5E6EBA-77EC-4E45-8681-83804B238F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A4F034-819B-5349-895D-CC1B85CFF6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D84BBF-4DB3-0440-858E-D2D952AE9A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639079-22A0-EF4B-B999-21354FCE0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BA785E-FD98-EA47-91EE-EEFD92375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A9AE3C-AF1C-8348-BE73-DC3ED0CB9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255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9F673-A059-B34A-BA62-D6083790D3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BBE93A-29D6-C444-81FF-02F1B985C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D3209C-2E6F-DE45-98A1-3DB3CF5CE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E90635-2AD0-DD48-9560-F25434C14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239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6EBF65-8D31-4F4E-A328-DFC976FA2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FECE7E-12B5-8942-AF0B-FB0C254B2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3E4620-0605-5445-9CE2-036CB067F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384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25AF9-5494-0144-9036-47D1A30DF5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7A4FA-F0C7-5345-BF47-739BFBF7C6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A44600-BCB1-724C-BA94-DB8C56B4A4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51C26D-61D7-9D43-908E-387E9EA00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ACD2E3-BC60-0240-881C-B77655981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B4D528-ED3C-E342-9B27-BB96E9BFF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550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29AEA-27A5-8245-A8EB-25C9AF0E76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2172F6-7064-5543-8287-D040533EEF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0BCB8F-1486-A642-9A64-71C9235907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92C211-46FF-EF4E-A5DF-361DA4C39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749704-3DF3-5C44-AF93-84F7D607F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578A23-EB0C-6348-AF5B-CDEF1BE32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997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A4CA3D-6954-614C-9CCC-417E897E6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83812A-645A-934C-BFBE-11CCCFF2D7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EFFEDD-3BC2-2047-B528-4DACBE8255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DBA127-E216-C540-91A3-F10317F34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949627-11AC-D044-BD3E-3062F688B2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803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1289B9E2-3E3E-8446-99EB-5E6A491E11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4942" y="290348"/>
            <a:ext cx="6293026" cy="629302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69B9DAC-A538-194B-89DB-1BDEDAACB545}"/>
              </a:ext>
            </a:extLst>
          </p:cNvPr>
          <p:cNvSpPr txBox="1"/>
          <p:nvPr/>
        </p:nvSpPr>
        <p:spPr>
          <a:xfrm>
            <a:off x="8593953" y="6293191"/>
            <a:ext cx="2600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ADA criteria: 1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AEC1F58-A519-2848-BC1E-2ADFC70F96CC}"/>
              </a:ext>
            </a:extLst>
          </p:cNvPr>
          <p:cNvGrpSpPr/>
          <p:nvPr/>
        </p:nvGrpSpPr>
        <p:grpSpPr>
          <a:xfrm>
            <a:off x="1406015" y="340451"/>
            <a:ext cx="10097384" cy="5923947"/>
            <a:chOff x="393629" y="122555"/>
            <a:chExt cx="11288824" cy="6859861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4D143D8-4E95-1E47-9AC2-2AB403E493BC}"/>
                </a:ext>
              </a:extLst>
            </p:cNvPr>
            <p:cNvSpPr txBox="1"/>
            <p:nvPr/>
          </p:nvSpPr>
          <p:spPr>
            <a:xfrm>
              <a:off x="393629" y="3253117"/>
              <a:ext cx="1284820" cy="3920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>
                  <a:latin typeface="Times" pitchFamily="2" charset="0"/>
                </a:rPr>
                <a:t>64 Complete Remission definition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6A2D400-81E6-F844-9E0C-87C7F215C79C}"/>
                </a:ext>
              </a:extLst>
            </p:cNvPr>
            <p:cNvSpPr txBox="1"/>
            <p:nvPr/>
          </p:nvSpPr>
          <p:spPr>
            <a:xfrm>
              <a:off x="3047985" y="5947514"/>
              <a:ext cx="897624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missing: 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1A35DAE-52F3-BD4A-82CA-78FC4BD375D7}"/>
                </a:ext>
              </a:extLst>
            </p:cNvPr>
            <p:cNvSpPr txBox="1"/>
            <p:nvPr/>
          </p:nvSpPr>
          <p:spPr>
            <a:xfrm>
              <a:off x="5105628" y="2552052"/>
              <a:ext cx="971181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>
                  <a:latin typeface="Times" pitchFamily="2" charset="0"/>
                </a:rPr>
                <a:t>missing: 2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3E53141-C9D4-FC4F-857E-E52831DDB776}"/>
                </a:ext>
              </a:extLst>
            </p:cNvPr>
            <p:cNvSpPr txBox="1"/>
            <p:nvPr/>
          </p:nvSpPr>
          <p:spPr>
            <a:xfrm>
              <a:off x="5099478" y="4122053"/>
              <a:ext cx="995321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>
                  <a:latin typeface="Times" pitchFamily="2" charset="0"/>
                </a:rPr>
                <a:t>at 1 year: 1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F498F43-1D44-6F4A-9A83-38A1CCE51F1A}"/>
                </a:ext>
              </a:extLst>
            </p:cNvPr>
            <p:cNvSpPr txBox="1"/>
            <p:nvPr/>
          </p:nvSpPr>
          <p:spPr>
            <a:xfrm>
              <a:off x="3548844" y="5301704"/>
              <a:ext cx="2600325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>
                  <a:latin typeface="Times" pitchFamily="2" charset="0"/>
                </a:rPr>
                <a:t>for 1 year: 25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1BE5E59-212C-B641-A7F2-18DF4C7F7856}"/>
                </a:ext>
              </a:extLst>
            </p:cNvPr>
            <p:cNvSpPr txBox="1"/>
            <p:nvPr/>
          </p:nvSpPr>
          <p:spPr>
            <a:xfrm>
              <a:off x="5061750" y="6719965"/>
              <a:ext cx="1098969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>
                  <a:latin typeface="Times" pitchFamily="2" charset="0"/>
                </a:rPr>
                <a:t>for 90 days: 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9A837E4-9F0B-A641-B239-853AF9076499}"/>
                </a:ext>
              </a:extLst>
            </p:cNvPr>
            <p:cNvSpPr txBox="1"/>
            <p:nvPr/>
          </p:nvSpPr>
          <p:spPr>
            <a:xfrm>
              <a:off x="8429896" y="122555"/>
              <a:ext cx="2600325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“2009 consensus criteria:” 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B9E18DC-B53A-AC47-83A2-A98589DFF034}"/>
                </a:ext>
              </a:extLst>
            </p:cNvPr>
            <p:cNvSpPr txBox="1"/>
            <p:nvPr/>
          </p:nvSpPr>
          <p:spPr>
            <a:xfrm>
              <a:off x="8429707" y="1809225"/>
              <a:ext cx="2600325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&lt;42mmol/mol: 2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7F7B6C6-28A2-AD43-8BDB-E76188F470B1}"/>
                </a:ext>
              </a:extLst>
            </p:cNvPr>
            <p:cNvSpPr txBox="1"/>
            <p:nvPr/>
          </p:nvSpPr>
          <p:spPr>
            <a:xfrm>
              <a:off x="8471963" y="2950175"/>
              <a:ext cx="2949183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/>
                <a:t>HbA1c &lt;</a:t>
              </a:r>
              <a:r>
                <a:rPr lang="en-GB" sz="800">
                  <a:latin typeface="Times" pitchFamily="2" charset="0"/>
                </a:rPr>
                <a:t>42mmol</a:t>
              </a:r>
              <a:r>
                <a:rPr lang="en-GB" sz="800"/>
                <a:t>/mol &amp; FPG &lt;6.1mmol/l :3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1A9F363-95FE-134D-8885-8D7FEE575D37}"/>
                </a:ext>
              </a:extLst>
            </p:cNvPr>
            <p:cNvSpPr txBox="1"/>
            <p:nvPr/>
          </p:nvSpPr>
          <p:spPr>
            <a:xfrm>
              <a:off x="8440215" y="5171609"/>
              <a:ext cx="3136514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 &lt;39mmol/mol &amp; FPG &lt;5.6mmol/l :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CF7DBF0-3347-CB40-953A-252E998144E2}"/>
                </a:ext>
              </a:extLst>
            </p:cNvPr>
            <p:cNvSpPr txBox="1"/>
            <p:nvPr/>
          </p:nvSpPr>
          <p:spPr>
            <a:xfrm>
              <a:off x="8419386" y="4243845"/>
              <a:ext cx="3157532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 &lt;42mmol/mol &amp; FPG &lt;5.6mmol/l: 14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206409A-02E1-0940-84E2-E80C61B74149}"/>
                </a:ext>
              </a:extLst>
            </p:cNvPr>
            <p:cNvSpPr txBox="1"/>
            <p:nvPr/>
          </p:nvSpPr>
          <p:spPr>
            <a:xfrm>
              <a:off x="8440215" y="6732934"/>
              <a:ext cx="2600325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 FPG &lt;5.6mmol/l: 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A67486B-EEB4-194F-A781-54517559A711}"/>
                </a:ext>
              </a:extLst>
            </p:cNvPr>
            <p:cNvSpPr txBox="1"/>
            <p:nvPr/>
          </p:nvSpPr>
          <p:spPr>
            <a:xfrm>
              <a:off x="8429707" y="6417022"/>
              <a:ext cx="3252746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 &lt;48mmol/mol &amp; FPG &lt;5.6mmol/l: 2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6A2F01C-25D1-4949-B0BE-325CB681B937}"/>
                </a:ext>
              </a:extLst>
            </p:cNvPr>
            <p:cNvSpPr txBox="1"/>
            <p:nvPr/>
          </p:nvSpPr>
          <p:spPr>
            <a:xfrm>
              <a:off x="8431280" y="6035444"/>
              <a:ext cx="2600325" cy="249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 &lt;39mmol/mol: 3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0C6E534C-F0AD-E442-B501-F32D35D90B3B}"/>
              </a:ext>
            </a:extLst>
          </p:cNvPr>
          <p:cNvSpPr txBox="1"/>
          <p:nvPr/>
        </p:nvSpPr>
        <p:spPr>
          <a:xfrm>
            <a:off x="5558747" y="6306403"/>
            <a:ext cx="10283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for 6 months:1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44B2821-CAEB-884F-8BAF-5781B5B63B81}"/>
              </a:ext>
            </a:extLst>
          </p:cNvPr>
          <p:cNvCxnSpPr>
            <a:cxnSpLocks/>
          </p:cNvCxnSpPr>
          <p:nvPr/>
        </p:nvCxnSpPr>
        <p:spPr>
          <a:xfrm>
            <a:off x="2604321" y="5436416"/>
            <a:ext cx="0" cy="1584743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0B684FB-B3E6-DE42-81BC-203B74D60C0C}"/>
              </a:ext>
            </a:extLst>
          </p:cNvPr>
          <p:cNvCxnSpPr>
            <a:cxnSpLocks/>
          </p:cNvCxnSpPr>
          <p:nvPr/>
        </p:nvCxnSpPr>
        <p:spPr>
          <a:xfrm>
            <a:off x="4583113" y="5814725"/>
            <a:ext cx="0" cy="1358825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02CA00B1-365A-664A-9EE6-1D4B2D0CC998}"/>
              </a:ext>
            </a:extLst>
          </p:cNvPr>
          <p:cNvCxnSpPr>
            <a:cxnSpLocks/>
          </p:cNvCxnSpPr>
          <p:nvPr/>
        </p:nvCxnSpPr>
        <p:spPr>
          <a:xfrm>
            <a:off x="6570639" y="6480744"/>
            <a:ext cx="0" cy="634106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9706A80B-0B7D-2240-AD65-D18C2DA878AC}"/>
              </a:ext>
            </a:extLst>
          </p:cNvPr>
          <p:cNvSpPr txBox="1"/>
          <p:nvPr/>
        </p:nvSpPr>
        <p:spPr>
          <a:xfrm>
            <a:off x="2674352" y="6527898"/>
            <a:ext cx="16130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GLT component</a:t>
            </a:r>
          </a:p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Reported 2 way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2C3D7B1-8499-7A4E-848C-1E4755C0B412}"/>
              </a:ext>
            </a:extLst>
          </p:cNvPr>
          <p:cNvSpPr txBox="1"/>
          <p:nvPr/>
        </p:nvSpPr>
        <p:spPr>
          <a:xfrm>
            <a:off x="4693825" y="6527898"/>
            <a:ext cx="16130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Time component</a:t>
            </a:r>
          </a:p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Reported 5 way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E3E373B-E0B4-BF45-8C5E-1EC86DE34FC7}"/>
              </a:ext>
            </a:extLst>
          </p:cNvPr>
          <p:cNvSpPr txBox="1"/>
          <p:nvPr/>
        </p:nvSpPr>
        <p:spPr>
          <a:xfrm>
            <a:off x="6714917" y="6527898"/>
            <a:ext cx="16130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Glycaemic component</a:t>
            </a:r>
          </a:p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Reported 13 way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5D1AB33-2354-0A45-94E4-CC85C1BE6908}"/>
              </a:ext>
            </a:extLst>
          </p:cNvPr>
          <p:cNvSpPr txBox="1"/>
          <p:nvPr/>
        </p:nvSpPr>
        <p:spPr>
          <a:xfrm>
            <a:off x="2613497" y="3210545"/>
            <a:ext cx="1941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absence of GLT specified: 6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D2B5DEB-E29F-474F-ACF0-B19D766D9EB6}"/>
              </a:ext>
            </a:extLst>
          </p:cNvPr>
          <p:cNvSpPr txBox="1"/>
          <p:nvPr/>
        </p:nvSpPr>
        <p:spPr>
          <a:xfrm>
            <a:off x="8594122" y="822407"/>
            <a:ext cx="26379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8mmol/mol, FPG &lt;5.6mmol/l :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76551C4-4433-8649-88A1-71C77832D6F7}"/>
              </a:ext>
            </a:extLst>
          </p:cNvPr>
          <p:cNvSpPr txBox="1"/>
          <p:nvPr/>
        </p:nvSpPr>
        <p:spPr>
          <a:xfrm>
            <a:off x="8593953" y="3178832"/>
            <a:ext cx="2824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2mmol/mol, FPG &lt;5.6mmol/l: 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3A2D548-1CC6-A64E-BCA0-5A18773B4833}"/>
              </a:ext>
            </a:extLst>
          </p:cNvPr>
          <p:cNvSpPr txBox="1"/>
          <p:nvPr/>
        </p:nvSpPr>
        <p:spPr>
          <a:xfrm>
            <a:off x="8656354" y="5099978"/>
            <a:ext cx="2824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2mmol/mol or FPG &lt;5.6mmol/l: 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966AFB4-DF58-4945-9A4F-220274A06572}"/>
              </a:ext>
            </a:extLst>
          </p:cNvPr>
          <p:cNvSpPr txBox="1"/>
          <p:nvPr/>
        </p:nvSpPr>
        <p:spPr>
          <a:xfrm>
            <a:off x="5397910" y="1435955"/>
            <a:ext cx="11727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at 18 months: 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64A662A-923C-8046-B626-7AEA41404A58}"/>
              </a:ext>
            </a:extLst>
          </p:cNvPr>
          <p:cNvSpPr txBox="1"/>
          <p:nvPr/>
        </p:nvSpPr>
        <p:spPr>
          <a:xfrm>
            <a:off x="3543700" y="5682550"/>
            <a:ext cx="10394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>
                <a:latin typeface="Times" pitchFamily="2" charset="0"/>
              </a:rPr>
              <a:t>Some GLT: 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D80F6CF-E259-BF47-818C-9280C6FDE643}"/>
              </a:ext>
            </a:extLst>
          </p:cNvPr>
          <p:cNvSpPr txBox="1"/>
          <p:nvPr/>
        </p:nvSpPr>
        <p:spPr>
          <a:xfrm>
            <a:off x="8594122" y="565261"/>
            <a:ext cx="28054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&lt; 39mmol/mol or FPG &lt;5.6mmol/l: 1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481BFEF-151F-9F41-99B1-748E580BF61A}"/>
              </a:ext>
            </a:extLst>
          </p:cNvPr>
          <p:cNvSpPr/>
          <p:nvPr/>
        </p:nvSpPr>
        <p:spPr>
          <a:xfrm>
            <a:off x="0" y="-2785"/>
            <a:ext cx="12192000" cy="2802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00"/>
              </a:spcAft>
            </a:pPr>
            <a:r>
              <a:rPr lang="en-GB" sz="1200" b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2 Fig: Sankey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iagram to illustrate heterogeneity for each component of the remission definition: glucose lowering therapy, time and glycaemic component for Partial Remission </a:t>
            </a:r>
            <a:endParaRPr lang="en-GB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9CD42491-B042-7541-ADFB-C78509AABE4B}"/>
              </a:ext>
            </a:extLst>
          </p:cNvPr>
          <p:cNvSpPr/>
          <p:nvPr/>
        </p:nvSpPr>
        <p:spPr>
          <a:xfrm>
            <a:off x="0" y="534270"/>
            <a:ext cx="4530398" cy="256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5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d indicates missing or ambiguous within each component only</a:t>
            </a:r>
            <a:endParaRPr lang="en-GB" sz="1050" b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15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842</Words>
  <Application>Microsoft Macintosh PowerPoint</Application>
  <PresentationFormat>Widescreen</PresentationFormat>
  <Paragraphs>1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PTIEUX Rae</dc:creator>
  <cp:lastModifiedBy>CAPTIEUX Rae</cp:lastModifiedBy>
  <cp:revision>4</cp:revision>
  <dcterms:created xsi:type="dcterms:W3CDTF">2020-09-01T19:34:41Z</dcterms:created>
  <dcterms:modified xsi:type="dcterms:W3CDTF">2020-09-24T21:32:06Z</dcterms:modified>
</cp:coreProperties>
</file>